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8C463-F6DA-40BE-AB73-1A041A725E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BFEB6-3715-427D-8F5D-2966B75D41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DD346-F1EF-4E4C-A918-B9A02BDC0B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0632F-BC27-4232-B4F0-8BA4ED5CA7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A116C-8B79-4B38-A7F5-01EA765F86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1B835-6EB2-4C40-BF74-2C3BDFE0EC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A59C8-E256-49D5-B5CA-275CE75277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32FFD-B178-47A7-8885-F27DEA9FE8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652D3-295D-43BA-AACE-2C0C499A10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A36B8-2CF5-4DD9-8991-A17F8338DD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BC715-0B39-4575-BC5A-8A8900B70F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5123C-53EF-4CCC-89C5-30D8669194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EAAB92-A9D6-471F-927D-2C097C8E12F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228600" y="533520"/>
            <a:ext cx="533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al-time PCR primers used to measure mRNA expression by rhesus macaque adipocyt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04920" y="838080"/>
          <a:ext cx="6172200" cy="4800600"/>
        </p:xfrm>
        <a:graphic>
          <a:graphicData uri="http://schemas.openxmlformats.org/drawingml/2006/table">
            <a:tbl>
              <a:tblPr/>
              <a:tblGrid>
                <a:gridCol w="1015920"/>
                <a:gridCol w="2655720"/>
                <a:gridCol w="2500560"/>
              </a:tblGrid>
              <a:tr h="2667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 Prim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rwar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ver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TCTGGAAAAACCTGCCAAG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ACCTGGTGCTCAGTGTAGC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AR</a:t>
                      </a:r>
                      <a:r>
                        <a:rPr b="0" lang="el-G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γ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CAATCAAAGTGGAGCCTG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CTTCTCCTTCTCGGCTTGT - 3’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/EBP</a:t>
                      </a:r>
                      <a:r>
                        <a:rPr b="0" lang="el-G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CTGGAGCTGACCAGTGACAA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AGGCACCGGAATCTCCTAGT - 3’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/EBP</a:t>
                      </a:r>
                      <a:r>
                        <a:rPr b="0" lang="el-G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TTTGTCCAAACCAACCGCAC 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CATCAACTTCGAAACCGGC - 3’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4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iponect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CGAGAAGGGTGAGAAAGGAGA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CATGTTGGGGACAGTAACGTAG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pt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CTGTGGGGATTCTTGTGGCT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CCGACTGCGTGTGTGAAATG - 3’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UT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AACATGGTTCGCATCGCT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ATCACCTCGTCCCTCGTGTA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-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TGTCACAAACAGTGCACCTACTT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AATGTGAGCATCCTGGTGAGTTT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-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TGGCTGAAAAAGATGGATGCT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TGCTCCTCACTACTCTCAAACCT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-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CGCAAGTTGAGGCAATTTCT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CTTTGTTGGTTGGGGTTCA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4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-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AGTTGCAAGGTAACAGCAATGAAG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AAGACAAGATGTTGTTTGCTAGG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-15R</a:t>
                      </a:r>
                      <a:r>
                        <a:rPr b="0" lang="el-G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ATGCCTTCCACATCGTCTT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TTGATGTAGCATGCCAGGAG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NF</a:t>
                      </a:r>
                      <a:r>
                        <a:rPr b="0" lang="el-G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GCTCAGGCAGTCAGATCAT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CTTGAGGGTTTGCTACAACATG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L-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TAGGAAGATCTCAGTGCAGAGGCT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GTCCATGGAATCCTGAACCCACTT - 3’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L-5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TACACCAGTGGCAAGTGCT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TGTACTCCCGAACCCATTT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L-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ATGGCCCTGCTACTGGCC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TTAACTGCTGCGGCGCTTCATCTT - 3’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4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L-2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AAGGAAGATTCCCGCCAAGG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- CAGCCCTTTCCCTTTTTGCC - 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Box 5"/>
          <p:cNvSpPr/>
          <p:nvPr/>
        </p:nvSpPr>
        <p:spPr>
          <a:xfrm>
            <a:off x="152280" y="15228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Jacob</dc:creator>
  <dc:description/>
  <dc:language>en-US</dc:language>
  <cp:lastModifiedBy>Jacob Couturier</cp:lastModifiedBy>
  <cp:lastPrinted>2015-12-14T17:50:23Z</cp:lastPrinted>
  <dcterms:modified xsi:type="dcterms:W3CDTF">2016-04-06T03:48:25Z</dcterms:modified>
  <cp:revision>3972</cp:revision>
  <dc:subject/>
  <dc:title>Slide 1</dc:title>
</cp:coreProperties>
</file>